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" userDrawn="1">
          <p15:clr>
            <a:srgbClr val="A4A3A4"/>
          </p15:clr>
        </p15:guide>
        <p15:guide id="2" pos="2026" userDrawn="1">
          <p15:clr>
            <a:srgbClr val="A4A3A4"/>
          </p15:clr>
        </p15:guide>
        <p15:guide id="3" orient="horz" pos="39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4EAC7A2-8929-EEDF-1005-E4F23D2BB211}" v="216" dt="2020-09-21T17:44:10.57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114"/>
      </p:cViewPr>
      <p:guideLst>
        <p:guide orient="horz" pos="311"/>
        <p:guide pos="2026"/>
        <p:guide orient="horz" pos="39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uan Fu [yuf4]" userId="2bf4daa5-2f5c-4582-aaab-6a7f8d79dd1f" providerId="ADAL" clId="{8FE4F8E0-4EEA-4D0B-B06B-F91F76F8C06E}"/>
    <pc:docChg chg="custSel addSld modSld sldOrd">
      <pc:chgData name="Yuan Fu [yuf4]" userId="2bf4daa5-2f5c-4582-aaab-6a7f8d79dd1f" providerId="ADAL" clId="{8FE4F8E0-4EEA-4D0B-B06B-F91F76F8C06E}" dt="2019-08-06T10:00:23.089" v="121" actId="20577"/>
      <pc:docMkLst>
        <pc:docMk/>
      </pc:docMkLst>
      <pc:sldChg chg="addSp delSp modSp add modNotesTx">
        <pc:chgData name="Yuan Fu [yuf4]" userId="2bf4daa5-2f5c-4582-aaab-6a7f8d79dd1f" providerId="ADAL" clId="{8FE4F8E0-4EEA-4D0B-B06B-F91F76F8C06E}" dt="2019-08-06T09:59:14.053" v="93" actId="14100"/>
        <pc:sldMkLst>
          <pc:docMk/>
          <pc:sldMk cId="2933284413" sldId="256"/>
        </pc:sldMkLst>
        <pc:spChg chg="add mod">
          <ac:chgData name="Yuan Fu [yuf4]" userId="2bf4daa5-2f5c-4582-aaab-6a7f8d79dd1f" providerId="ADAL" clId="{8FE4F8E0-4EEA-4D0B-B06B-F91F76F8C06E}" dt="2019-08-06T09:59:14.053" v="93" actId="14100"/>
          <ac:spMkLst>
            <pc:docMk/>
            <pc:sldMk cId="2933284413" sldId="256"/>
            <ac:spMk id="5" creationId="{68E9B8E9-1168-4C08-B7F5-CA724609920E}"/>
          </ac:spMkLst>
        </pc:spChg>
        <pc:graphicFrameChg chg="add del mod">
          <ac:chgData name="Yuan Fu [yuf4]" userId="2bf4daa5-2f5c-4582-aaab-6a7f8d79dd1f" providerId="ADAL" clId="{8FE4F8E0-4EEA-4D0B-B06B-F91F76F8C06E}" dt="2019-08-06T09:52:11.354" v="2" actId="478"/>
          <ac:graphicFrameMkLst>
            <pc:docMk/>
            <pc:sldMk cId="2933284413" sldId="256"/>
            <ac:graphicFrameMk id="2" creationId="{E20AF9C6-3A7B-4DFC-A94A-A8CEB106D973}"/>
          </ac:graphicFrameMkLst>
        </pc:graphicFrameChg>
        <pc:picChg chg="add mod">
          <ac:chgData name="Yuan Fu [yuf4]" userId="2bf4daa5-2f5c-4582-aaab-6a7f8d79dd1f" providerId="ADAL" clId="{8FE4F8E0-4EEA-4D0B-B06B-F91F76F8C06E}" dt="2019-08-06T09:54:39.044" v="3"/>
          <ac:picMkLst>
            <pc:docMk/>
            <pc:sldMk cId="2933284413" sldId="256"/>
            <ac:picMk id="4" creationId="{7B3AC9E0-544E-4EC5-A85D-50B44662D2C6}"/>
          </ac:picMkLst>
        </pc:picChg>
      </pc:sldChg>
      <pc:sldChg chg="addSp modSp add modNotesTx">
        <pc:chgData name="Yuan Fu [yuf4]" userId="2bf4daa5-2f5c-4582-aaab-6a7f8d79dd1f" providerId="ADAL" clId="{8FE4F8E0-4EEA-4D0B-B06B-F91F76F8C06E}" dt="2019-08-06T09:59:10.094" v="92" actId="14100"/>
        <pc:sldMkLst>
          <pc:docMk/>
          <pc:sldMk cId="2941776132" sldId="257"/>
        </pc:sldMkLst>
        <pc:spChg chg="add mod">
          <ac:chgData name="Yuan Fu [yuf4]" userId="2bf4daa5-2f5c-4582-aaab-6a7f8d79dd1f" providerId="ADAL" clId="{8FE4F8E0-4EEA-4D0B-B06B-F91F76F8C06E}" dt="2019-08-06T09:59:10.094" v="92" actId="14100"/>
          <ac:spMkLst>
            <pc:docMk/>
            <pc:sldMk cId="2941776132" sldId="257"/>
            <ac:spMk id="4" creationId="{48215377-BDD6-4D98-8A40-F57907C2F5D9}"/>
          </ac:spMkLst>
        </pc:spChg>
        <pc:picChg chg="add mod">
          <ac:chgData name="Yuan Fu [yuf4]" userId="2bf4daa5-2f5c-4582-aaab-6a7f8d79dd1f" providerId="ADAL" clId="{8FE4F8E0-4EEA-4D0B-B06B-F91F76F8C06E}" dt="2019-08-06T09:55:05.389" v="10"/>
          <ac:picMkLst>
            <pc:docMk/>
            <pc:sldMk cId="2941776132" sldId="257"/>
            <ac:picMk id="3" creationId="{CC17361D-A059-497B-A748-CE8F73843C4D}"/>
          </ac:picMkLst>
        </pc:picChg>
      </pc:sldChg>
      <pc:sldChg chg="addSp modSp add">
        <pc:chgData name="Yuan Fu [yuf4]" userId="2bf4daa5-2f5c-4582-aaab-6a7f8d79dd1f" providerId="ADAL" clId="{8FE4F8E0-4EEA-4D0B-B06B-F91F76F8C06E}" dt="2019-08-06T09:59:05.050" v="91" actId="14100"/>
        <pc:sldMkLst>
          <pc:docMk/>
          <pc:sldMk cId="4245190981" sldId="258"/>
        </pc:sldMkLst>
        <pc:spChg chg="add mod">
          <ac:chgData name="Yuan Fu [yuf4]" userId="2bf4daa5-2f5c-4582-aaab-6a7f8d79dd1f" providerId="ADAL" clId="{8FE4F8E0-4EEA-4D0B-B06B-F91F76F8C06E}" dt="2019-08-06T09:59:05.050" v="91" actId="14100"/>
          <ac:spMkLst>
            <pc:docMk/>
            <pc:sldMk cId="4245190981" sldId="258"/>
            <ac:spMk id="4" creationId="{5D0B4989-557A-4C42-B24E-FCAA3A79B270}"/>
          </ac:spMkLst>
        </pc:spChg>
        <pc:picChg chg="add mod">
          <ac:chgData name="Yuan Fu [yuf4]" userId="2bf4daa5-2f5c-4582-aaab-6a7f8d79dd1f" providerId="ADAL" clId="{8FE4F8E0-4EEA-4D0B-B06B-F91F76F8C06E}" dt="2019-08-06T09:55:31.068" v="26"/>
          <ac:picMkLst>
            <pc:docMk/>
            <pc:sldMk cId="4245190981" sldId="258"/>
            <ac:picMk id="3" creationId="{A0E7A82C-5A3D-4B4F-93CD-CAC214439DEF}"/>
          </ac:picMkLst>
        </pc:picChg>
      </pc:sldChg>
      <pc:sldChg chg="addSp modSp add">
        <pc:chgData name="Yuan Fu [yuf4]" userId="2bf4daa5-2f5c-4582-aaab-6a7f8d79dd1f" providerId="ADAL" clId="{8FE4F8E0-4EEA-4D0B-B06B-F91F76F8C06E}" dt="2019-08-06T09:58:51.131" v="90" actId="14100"/>
        <pc:sldMkLst>
          <pc:docMk/>
          <pc:sldMk cId="1775050043" sldId="259"/>
        </pc:sldMkLst>
        <pc:spChg chg="add mod">
          <ac:chgData name="Yuan Fu [yuf4]" userId="2bf4daa5-2f5c-4582-aaab-6a7f8d79dd1f" providerId="ADAL" clId="{8FE4F8E0-4EEA-4D0B-B06B-F91F76F8C06E}" dt="2019-08-06T09:58:51.131" v="90" actId="14100"/>
          <ac:spMkLst>
            <pc:docMk/>
            <pc:sldMk cId="1775050043" sldId="259"/>
            <ac:spMk id="4" creationId="{990B0A35-FA6E-4E23-B7CC-EE33BAEDAA52}"/>
          </ac:spMkLst>
        </pc:spChg>
        <pc:picChg chg="add mod">
          <ac:chgData name="Yuan Fu [yuf4]" userId="2bf4daa5-2f5c-4582-aaab-6a7f8d79dd1f" providerId="ADAL" clId="{8FE4F8E0-4EEA-4D0B-B06B-F91F76F8C06E}" dt="2019-08-06T09:55:36.343" v="27"/>
          <ac:picMkLst>
            <pc:docMk/>
            <pc:sldMk cId="1775050043" sldId="259"/>
            <ac:picMk id="3" creationId="{C761A660-AC78-4334-A5CC-0237C9B01208}"/>
          </ac:picMkLst>
        </pc:picChg>
      </pc:sldChg>
      <pc:sldChg chg="addSp modSp add">
        <pc:chgData name="Yuan Fu [yuf4]" userId="2bf4daa5-2f5c-4582-aaab-6a7f8d79dd1f" providerId="ADAL" clId="{8FE4F8E0-4EEA-4D0B-B06B-F91F76F8C06E}" dt="2019-08-06T09:59:30.173" v="102" actId="20577"/>
        <pc:sldMkLst>
          <pc:docMk/>
          <pc:sldMk cId="310228240" sldId="260"/>
        </pc:sldMkLst>
        <pc:spChg chg="add mod">
          <ac:chgData name="Yuan Fu [yuf4]" userId="2bf4daa5-2f5c-4582-aaab-6a7f8d79dd1f" providerId="ADAL" clId="{8FE4F8E0-4EEA-4D0B-B06B-F91F76F8C06E}" dt="2019-08-06T09:59:30.173" v="102" actId="20577"/>
          <ac:spMkLst>
            <pc:docMk/>
            <pc:sldMk cId="310228240" sldId="260"/>
            <ac:spMk id="4" creationId="{BA19E53A-B318-4305-BD1A-335F2077B3E4}"/>
          </ac:spMkLst>
        </pc:spChg>
        <pc:picChg chg="add mod">
          <ac:chgData name="Yuan Fu [yuf4]" userId="2bf4daa5-2f5c-4582-aaab-6a7f8d79dd1f" providerId="ADAL" clId="{8FE4F8E0-4EEA-4D0B-B06B-F91F76F8C06E}" dt="2019-08-06T09:55:41.591" v="28"/>
          <ac:picMkLst>
            <pc:docMk/>
            <pc:sldMk cId="310228240" sldId="260"/>
            <ac:picMk id="3" creationId="{9B5152C3-EAE4-4098-904B-50788CDAA560}"/>
          </ac:picMkLst>
        </pc:picChg>
      </pc:sldChg>
      <pc:sldChg chg="addSp modSp add">
        <pc:chgData name="Yuan Fu [yuf4]" userId="2bf4daa5-2f5c-4582-aaab-6a7f8d79dd1f" providerId="ADAL" clId="{8FE4F8E0-4EEA-4D0B-B06B-F91F76F8C06E}" dt="2019-08-06T09:59:36.223" v="103"/>
        <pc:sldMkLst>
          <pc:docMk/>
          <pc:sldMk cId="1613560427" sldId="261"/>
        </pc:sldMkLst>
        <pc:spChg chg="add">
          <ac:chgData name="Yuan Fu [yuf4]" userId="2bf4daa5-2f5c-4582-aaab-6a7f8d79dd1f" providerId="ADAL" clId="{8FE4F8E0-4EEA-4D0B-B06B-F91F76F8C06E}" dt="2019-08-06T09:59:36.223" v="103"/>
          <ac:spMkLst>
            <pc:docMk/>
            <pc:sldMk cId="1613560427" sldId="261"/>
            <ac:spMk id="4" creationId="{182CA3AE-4716-424C-8D72-102BBBF8042A}"/>
          </ac:spMkLst>
        </pc:spChg>
        <pc:picChg chg="add mod">
          <ac:chgData name="Yuan Fu [yuf4]" userId="2bf4daa5-2f5c-4582-aaab-6a7f8d79dd1f" providerId="ADAL" clId="{8FE4F8E0-4EEA-4D0B-B06B-F91F76F8C06E}" dt="2019-08-06T09:55:46.923" v="29"/>
          <ac:picMkLst>
            <pc:docMk/>
            <pc:sldMk cId="1613560427" sldId="261"/>
            <ac:picMk id="3" creationId="{CF471A61-B816-417C-8E33-454C94218C07}"/>
          </ac:picMkLst>
        </pc:picChg>
      </pc:sldChg>
      <pc:sldChg chg="addSp modSp add">
        <pc:chgData name="Yuan Fu [yuf4]" userId="2bf4daa5-2f5c-4582-aaab-6a7f8d79dd1f" providerId="ADAL" clId="{8FE4F8E0-4EEA-4D0B-B06B-F91F76F8C06E}" dt="2019-08-06T09:59:47.737" v="110" actId="20577"/>
        <pc:sldMkLst>
          <pc:docMk/>
          <pc:sldMk cId="375304426" sldId="262"/>
        </pc:sldMkLst>
        <pc:spChg chg="add mod">
          <ac:chgData name="Yuan Fu [yuf4]" userId="2bf4daa5-2f5c-4582-aaab-6a7f8d79dd1f" providerId="ADAL" clId="{8FE4F8E0-4EEA-4D0B-B06B-F91F76F8C06E}" dt="2019-08-06T09:59:47.737" v="110" actId="20577"/>
          <ac:spMkLst>
            <pc:docMk/>
            <pc:sldMk cId="375304426" sldId="262"/>
            <ac:spMk id="4" creationId="{64CD51AE-5507-499A-87EA-8F765194A2BF}"/>
          </ac:spMkLst>
        </pc:spChg>
        <pc:picChg chg="add mod">
          <ac:chgData name="Yuan Fu [yuf4]" userId="2bf4daa5-2f5c-4582-aaab-6a7f8d79dd1f" providerId="ADAL" clId="{8FE4F8E0-4EEA-4D0B-B06B-F91F76F8C06E}" dt="2019-08-06T09:55:54.595" v="30"/>
          <ac:picMkLst>
            <pc:docMk/>
            <pc:sldMk cId="375304426" sldId="262"/>
            <ac:picMk id="3" creationId="{7D527B90-5FF5-46FB-9248-66E913D48950}"/>
          </ac:picMkLst>
        </pc:picChg>
      </pc:sldChg>
      <pc:sldChg chg="addSp modSp add">
        <pc:chgData name="Yuan Fu [yuf4]" userId="2bf4daa5-2f5c-4582-aaab-6a7f8d79dd1f" providerId="ADAL" clId="{8FE4F8E0-4EEA-4D0B-B06B-F91F76F8C06E}" dt="2019-08-06T09:59:53.742" v="111"/>
        <pc:sldMkLst>
          <pc:docMk/>
          <pc:sldMk cId="2644330033" sldId="263"/>
        </pc:sldMkLst>
        <pc:spChg chg="add">
          <ac:chgData name="Yuan Fu [yuf4]" userId="2bf4daa5-2f5c-4582-aaab-6a7f8d79dd1f" providerId="ADAL" clId="{8FE4F8E0-4EEA-4D0B-B06B-F91F76F8C06E}" dt="2019-08-06T09:59:53.742" v="111"/>
          <ac:spMkLst>
            <pc:docMk/>
            <pc:sldMk cId="2644330033" sldId="263"/>
            <ac:spMk id="4" creationId="{16C6D885-3D5E-495A-B008-CC29BA5CF5AE}"/>
          </ac:spMkLst>
        </pc:spChg>
        <pc:picChg chg="add mod">
          <ac:chgData name="Yuan Fu [yuf4]" userId="2bf4daa5-2f5c-4582-aaab-6a7f8d79dd1f" providerId="ADAL" clId="{8FE4F8E0-4EEA-4D0B-B06B-F91F76F8C06E}" dt="2019-08-06T09:55:59.892" v="31"/>
          <ac:picMkLst>
            <pc:docMk/>
            <pc:sldMk cId="2644330033" sldId="263"/>
            <ac:picMk id="3" creationId="{8BB4279D-62E6-4CFB-B538-446B9A17440D}"/>
          </ac:picMkLst>
        </pc:picChg>
      </pc:sldChg>
      <pc:sldChg chg="addSp modSp add ord">
        <pc:chgData name="Yuan Fu [yuf4]" userId="2bf4daa5-2f5c-4582-aaab-6a7f8d79dd1f" providerId="ADAL" clId="{8FE4F8E0-4EEA-4D0B-B06B-F91F76F8C06E}" dt="2019-08-06T10:00:23.089" v="121" actId="20577"/>
        <pc:sldMkLst>
          <pc:docMk/>
          <pc:sldMk cId="1250990985" sldId="264"/>
        </pc:sldMkLst>
        <pc:spChg chg="add mod">
          <ac:chgData name="Yuan Fu [yuf4]" userId="2bf4daa5-2f5c-4582-aaab-6a7f8d79dd1f" providerId="ADAL" clId="{8FE4F8E0-4EEA-4D0B-B06B-F91F76F8C06E}" dt="2019-08-06T10:00:23.089" v="121" actId="20577"/>
          <ac:spMkLst>
            <pc:docMk/>
            <pc:sldMk cId="1250990985" sldId="264"/>
            <ac:spMk id="4" creationId="{94692B90-96E6-404E-80BD-5F2C6582419C}"/>
          </ac:spMkLst>
        </pc:spChg>
        <pc:picChg chg="add mod">
          <ac:chgData name="Yuan Fu [yuf4]" userId="2bf4daa5-2f5c-4582-aaab-6a7f8d79dd1f" providerId="ADAL" clId="{8FE4F8E0-4EEA-4D0B-B06B-F91F76F8C06E}" dt="2019-08-06T09:56:12.060" v="36"/>
          <ac:picMkLst>
            <pc:docMk/>
            <pc:sldMk cId="1250990985" sldId="264"/>
            <ac:picMk id="3" creationId="{823B012E-A57C-4492-A40D-BC8BC2ACDF2A}"/>
          </ac:picMkLst>
        </pc:picChg>
      </pc:sldChg>
      <pc:sldChg chg="addSp modSp add">
        <pc:chgData name="Yuan Fu [yuf4]" userId="2bf4daa5-2f5c-4582-aaab-6a7f8d79dd1f" providerId="ADAL" clId="{8FE4F8E0-4EEA-4D0B-B06B-F91F76F8C06E}" dt="2019-08-06T10:00:08.994" v="115" actId="20577"/>
        <pc:sldMkLst>
          <pc:docMk/>
          <pc:sldMk cId="3314443409" sldId="265"/>
        </pc:sldMkLst>
        <pc:spChg chg="add mod">
          <ac:chgData name="Yuan Fu [yuf4]" userId="2bf4daa5-2f5c-4582-aaab-6a7f8d79dd1f" providerId="ADAL" clId="{8FE4F8E0-4EEA-4D0B-B06B-F91F76F8C06E}" dt="2019-08-06T10:00:08.994" v="115" actId="20577"/>
          <ac:spMkLst>
            <pc:docMk/>
            <pc:sldMk cId="3314443409" sldId="265"/>
            <ac:spMk id="4" creationId="{C64F32FB-8F70-40A0-91DA-4C4DFCB62010}"/>
          </ac:spMkLst>
        </pc:spChg>
        <pc:picChg chg="add mod">
          <ac:chgData name="Yuan Fu [yuf4]" userId="2bf4daa5-2f5c-4582-aaab-6a7f8d79dd1f" providerId="ADAL" clId="{8FE4F8E0-4EEA-4D0B-B06B-F91F76F8C06E}" dt="2019-08-06T09:56:05.845" v="34"/>
          <ac:picMkLst>
            <pc:docMk/>
            <pc:sldMk cId="3314443409" sldId="265"/>
            <ac:picMk id="3" creationId="{100EA68C-E443-4574-8DAA-2EF2FCE536AF}"/>
          </ac:picMkLst>
        </pc:picChg>
      </pc:sldChg>
    </pc:docChg>
  </pc:docChgLst>
  <pc:docChgLst>
    <pc:chgData name="Yuan Fu [yuf4]" userId="2bf4daa5-2f5c-4582-aaab-6a7f8d79dd1f" providerId="ADAL" clId="{ED45921D-0B63-4063-8E0C-A31C5FE00B50}"/>
    <pc:docChg chg="custSel modSld">
      <pc:chgData name="Yuan Fu [yuf4]" userId="2bf4daa5-2f5c-4582-aaab-6a7f8d79dd1f" providerId="ADAL" clId="{ED45921D-0B63-4063-8E0C-A31C5FE00B50}" dt="2020-09-21T19:40:32.160" v="7" actId="478"/>
      <pc:docMkLst>
        <pc:docMk/>
      </pc:docMkLst>
      <pc:sldChg chg="delSp mod">
        <pc:chgData name="Yuan Fu [yuf4]" userId="2bf4daa5-2f5c-4582-aaab-6a7f8d79dd1f" providerId="ADAL" clId="{ED45921D-0B63-4063-8E0C-A31C5FE00B50}" dt="2020-09-21T19:40:32.160" v="7" actId="478"/>
        <pc:sldMkLst>
          <pc:docMk/>
          <pc:sldMk cId="310228240" sldId="260"/>
        </pc:sldMkLst>
        <pc:picChg chg="del">
          <ac:chgData name="Yuan Fu [yuf4]" userId="2bf4daa5-2f5c-4582-aaab-6a7f8d79dd1f" providerId="ADAL" clId="{ED45921D-0B63-4063-8E0C-A31C5FE00B50}" dt="2020-09-21T19:40:32.160" v="7" actId="478"/>
          <ac:picMkLst>
            <pc:docMk/>
            <pc:sldMk cId="310228240" sldId="260"/>
            <ac:picMk id="2" creationId="{7D26005F-BD3F-4D96-999E-92F184453E24}"/>
          </ac:picMkLst>
        </pc:picChg>
      </pc:sldChg>
      <pc:sldChg chg="delSp modSp mod">
        <pc:chgData name="Yuan Fu [yuf4]" userId="2bf4daa5-2f5c-4582-aaab-6a7f8d79dd1f" providerId="ADAL" clId="{ED45921D-0B63-4063-8E0C-A31C5FE00B50}" dt="2020-09-21T19:40:24.684" v="6" actId="478"/>
        <pc:sldMkLst>
          <pc:docMk/>
          <pc:sldMk cId="1613560427" sldId="261"/>
        </pc:sldMkLst>
        <pc:spChg chg="mod">
          <ac:chgData name="Yuan Fu [yuf4]" userId="2bf4daa5-2f5c-4582-aaab-6a7f8d79dd1f" providerId="ADAL" clId="{ED45921D-0B63-4063-8E0C-A31C5FE00B50}" dt="2020-09-21T19:39:14.617" v="5"/>
          <ac:spMkLst>
            <pc:docMk/>
            <pc:sldMk cId="1613560427" sldId="261"/>
            <ac:spMk id="6" creationId="{DF8E5972-A3AC-4031-B145-FB27E7FEFAAB}"/>
          </ac:spMkLst>
        </pc:spChg>
        <pc:picChg chg="del">
          <ac:chgData name="Yuan Fu [yuf4]" userId="2bf4daa5-2f5c-4582-aaab-6a7f8d79dd1f" providerId="ADAL" clId="{ED45921D-0B63-4063-8E0C-A31C5FE00B50}" dt="2020-09-21T19:40:24.684" v="6" actId="478"/>
          <ac:picMkLst>
            <pc:docMk/>
            <pc:sldMk cId="1613560427" sldId="261"/>
            <ac:picMk id="2" creationId="{7EBC41AD-CA2C-44FC-B284-43B9E45A080F}"/>
          </ac:picMkLst>
        </pc:picChg>
      </pc:sldChg>
    </pc:docChg>
  </pc:docChgLst>
  <pc:docChgLst>
    <pc:chgData name="Yuan Fu [yuf4]" userId="S::yuf4@aber.ac.uk::2bf4daa5-2f5c-4582-aaab-6a7f8d79dd1f" providerId="AD" clId="Web-{24EAC7A2-8929-EEDF-1005-E4F23D2BB211}"/>
    <pc:docChg chg="delSld modSld">
      <pc:chgData name="Yuan Fu [yuf4]" userId="S::yuf4@aber.ac.uk::2bf4daa5-2f5c-4582-aaab-6a7f8d79dd1f" providerId="AD" clId="Web-{24EAC7A2-8929-EEDF-1005-E4F23D2BB211}" dt="2020-09-21T17:44:08.261" v="203" actId="20577"/>
      <pc:docMkLst>
        <pc:docMk/>
      </pc:docMkLst>
      <pc:sldChg chg="addSp modSp">
        <pc:chgData name="Yuan Fu [yuf4]" userId="S::yuf4@aber.ac.uk::2bf4daa5-2f5c-4582-aaab-6a7f8d79dd1f" providerId="AD" clId="Web-{24EAC7A2-8929-EEDF-1005-E4F23D2BB211}" dt="2020-09-21T17:18:20.013" v="68" actId="20577"/>
        <pc:sldMkLst>
          <pc:docMk/>
          <pc:sldMk cId="2933284413" sldId="256"/>
        </pc:sldMkLst>
        <pc:spChg chg="add mod">
          <ac:chgData name="Yuan Fu [yuf4]" userId="S::yuf4@aber.ac.uk::2bf4daa5-2f5c-4582-aaab-6a7f8d79dd1f" providerId="AD" clId="Web-{24EAC7A2-8929-EEDF-1005-E4F23D2BB211}" dt="2020-09-21T17:18:20.013" v="68" actId="20577"/>
          <ac:spMkLst>
            <pc:docMk/>
            <pc:sldMk cId="2933284413" sldId="256"/>
            <ac:spMk id="2" creationId="{84A7FC12-E8EC-4AF8-97CF-793EEE4BB807}"/>
          </ac:spMkLst>
        </pc:spChg>
      </pc:sldChg>
      <pc:sldChg chg="addSp modSp">
        <pc:chgData name="Yuan Fu [yuf4]" userId="S::yuf4@aber.ac.uk::2bf4daa5-2f5c-4582-aaab-6a7f8d79dd1f" providerId="AD" clId="Web-{24EAC7A2-8929-EEDF-1005-E4F23D2BB211}" dt="2020-09-21T17:21:39.876" v="171" actId="20577"/>
        <pc:sldMkLst>
          <pc:docMk/>
          <pc:sldMk cId="2941776132" sldId="257"/>
        </pc:sldMkLst>
        <pc:spChg chg="add mod">
          <ac:chgData name="Yuan Fu [yuf4]" userId="S::yuf4@aber.ac.uk::2bf4daa5-2f5c-4582-aaab-6a7f8d79dd1f" providerId="AD" clId="Web-{24EAC7A2-8929-EEDF-1005-E4F23D2BB211}" dt="2020-09-21T17:21:39.876" v="171" actId="20577"/>
          <ac:spMkLst>
            <pc:docMk/>
            <pc:sldMk cId="2941776132" sldId="257"/>
            <ac:spMk id="2" creationId="{0A139084-E40F-4704-8EB2-52C252DEE177}"/>
          </ac:spMkLst>
        </pc:spChg>
      </pc:sldChg>
      <pc:sldChg chg="addSp modSp">
        <pc:chgData name="Yuan Fu [yuf4]" userId="S::yuf4@aber.ac.uk::2bf4daa5-2f5c-4582-aaab-6a7f8d79dd1f" providerId="AD" clId="Web-{24EAC7A2-8929-EEDF-1005-E4F23D2BB211}" dt="2020-09-21T17:18:16.091" v="64" actId="20577"/>
        <pc:sldMkLst>
          <pc:docMk/>
          <pc:sldMk cId="4245190981" sldId="258"/>
        </pc:sldMkLst>
        <pc:spChg chg="add mod">
          <ac:chgData name="Yuan Fu [yuf4]" userId="S::yuf4@aber.ac.uk::2bf4daa5-2f5c-4582-aaab-6a7f8d79dd1f" providerId="AD" clId="Web-{24EAC7A2-8929-EEDF-1005-E4F23D2BB211}" dt="2020-09-21T17:18:16.091" v="64" actId="20577"/>
          <ac:spMkLst>
            <pc:docMk/>
            <pc:sldMk cId="4245190981" sldId="258"/>
            <ac:spMk id="2" creationId="{884DA3D9-B66A-44EB-9B9E-F5AF8F863011}"/>
          </ac:spMkLst>
        </pc:spChg>
      </pc:sldChg>
      <pc:sldChg chg="addSp modSp">
        <pc:chgData name="Yuan Fu [yuf4]" userId="S::yuf4@aber.ac.uk::2bf4daa5-2f5c-4582-aaab-6a7f8d79dd1f" providerId="AD" clId="Web-{24EAC7A2-8929-EEDF-1005-E4F23D2BB211}" dt="2020-09-21T17:27:50.289" v="194" actId="1076"/>
        <pc:sldMkLst>
          <pc:docMk/>
          <pc:sldMk cId="1775050043" sldId="259"/>
        </pc:sldMkLst>
        <pc:spChg chg="add mod">
          <ac:chgData name="Yuan Fu [yuf4]" userId="S::yuf4@aber.ac.uk::2bf4daa5-2f5c-4582-aaab-6a7f8d79dd1f" providerId="AD" clId="Web-{24EAC7A2-8929-EEDF-1005-E4F23D2BB211}" dt="2020-09-21T17:21:25.891" v="154" actId="20577"/>
          <ac:spMkLst>
            <pc:docMk/>
            <pc:sldMk cId="1775050043" sldId="259"/>
            <ac:spMk id="2" creationId="{C14A09D1-E66F-4BE9-A7AE-98FDDFA7932C}"/>
          </ac:spMkLst>
        </pc:spChg>
        <pc:spChg chg="mod">
          <ac:chgData name="Yuan Fu [yuf4]" userId="S::yuf4@aber.ac.uk::2bf4daa5-2f5c-4582-aaab-6a7f8d79dd1f" providerId="AD" clId="Web-{24EAC7A2-8929-EEDF-1005-E4F23D2BB211}" dt="2020-09-21T17:27:50.289" v="194" actId="1076"/>
          <ac:spMkLst>
            <pc:docMk/>
            <pc:sldMk cId="1775050043" sldId="259"/>
            <ac:spMk id="4" creationId="{990B0A35-FA6E-4E23-B7CC-EE33BAEDAA52}"/>
          </ac:spMkLst>
        </pc:spChg>
      </pc:sldChg>
      <pc:sldChg chg="addSp modSp">
        <pc:chgData name="Yuan Fu [yuf4]" userId="S::yuf4@aber.ac.uk::2bf4daa5-2f5c-4582-aaab-6a7f8d79dd1f" providerId="AD" clId="Web-{24EAC7A2-8929-EEDF-1005-E4F23D2BB211}" dt="2020-09-21T17:27:56.180" v="195" actId="1076"/>
        <pc:sldMkLst>
          <pc:docMk/>
          <pc:sldMk cId="310228240" sldId="260"/>
        </pc:sldMkLst>
        <pc:spChg chg="mod">
          <ac:chgData name="Yuan Fu [yuf4]" userId="S::yuf4@aber.ac.uk::2bf4daa5-2f5c-4582-aaab-6a7f8d79dd1f" providerId="AD" clId="Web-{24EAC7A2-8929-EEDF-1005-E4F23D2BB211}" dt="2020-09-21T17:27:56.180" v="195" actId="1076"/>
          <ac:spMkLst>
            <pc:docMk/>
            <pc:sldMk cId="310228240" sldId="260"/>
            <ac:spMk id="4" creationId="{BA19E53A-B318-4305-BD1A-335F2077B3E4}"/>
          </ac:spMkLst>
        </pc:spChg>
        <pc:spChg chg="add mod">
          <ac:chgData name="Yuan Fu [yuf4]" userId="S::yuf4@aber.ac.uk::2bf4daa5-2f5c-4582-aaab-6a7f8d79dd1f" providerId="AD" clId="Web-{24EAC7A2-8929-EEDF-1005-E4F23D2BB211}" dt="2020-09-21T17:19:38.717" v="99" actId="20577"/>
          <ac:spMkLst>
            <pc:docMk/>
            <pc:sldMk cId="310228240" sldId="260"/>
            <ac:spMk id="6" creationId="{02AD75E5-3DE3-4F59-A0BA-C7D7422F0B94}"/>
          </ac:spMkLst>
        </pc:spChg>
      </pc:sldChg>
      <pc:sldChg chg="addSp modSp">
        <pc:chgData name="Yuan Fu [yuf4]" userId="S::yuf4@aber.ac.uk::2bf4daa5-2f5c-4582-aaab-6a7f8d79dd1f" providerId="AD" clId="Web-{24EAC7A2-8929-EEDF-1005-E4F23D2BB211}" dt="2020-09-21T17:44:08.261" v="202" actId="20577"/>
        <pc:sldMkLst>
          <pc:docMk/>
          <pc:sldMk cId="1613560427" sldId="261"/>
        </pc:sldMkLst>
        <pc:spChg chg="mod">
          <ac:chgData name="Yuan Fu [yuf4]" userId="S::yuf4@aber.ac.uk::2bf4daa5-2f5c-4582-aaab-6a7f8d79dd1f" providerId="AD" clId="Web-{24EAC7A2-8929-EEDF-1005-E4F23D2BB211}" dt="2020-09-21T17:13:29.085" v="0" actId="1076"/>
          <ac:spMkLst>
            <pc:docMk/>
            <pc:sldMk cId="1613560427" sldId="261"/>
            <ac:spMk id="4" creationId="{182CA3AE-4716-424C-8D72-102BBBF8042A}"/>
          </ac:spMkLst>
        </pc:spChg>
        <pc:spChg chg="add mod">
          <ac:chgData name="Yuan Fu [yuf4]" userId="S::yuf4@aber.ac.uk::2bf4daa5-2f5c-4582-aaab-6a7f8d79dd1f" providerId="AD" clId="Web-{24EAC7A2-8929-EEDF-1005-E4F23D2BB211}" dt="2020-09-21T17:44:08.261" v="202" actId="20577"/>
          <ac:spMkLst>
            <pc:docMk/>
            <pc:sldMk cId="1613560427" sldId="261"/>
            <ac:spMk id="6" creationId="{DF8E5972-A3AC-4031-B145-FB27E7FEFAAB}"/>
          </ac:spMkLst>
        </pc:spChg>
      </pc:sldChg>
      <pc:sldChg chg="addSp modSp">
        <pc:chgData name="Yuan Fu [yuf4]" userId="S::yuf4@aber.ac.uk::2bf4daa5-2f5c-4582-aaab-6a7f8d79dd1f" providerId="AD" clId="Web-{24EAC7A2-8929-EEDF-1005-E4F23D2BB211}" dt="2020-09-21T17:28:22.696" v="196" actId="1076"/>
        <pc:sldMkLst>
          <pc:docMk/>
          <pc:sldMk cId="375304426" sldId="262"/>
        </pc:sldMkLst>
        <pc:spChg chg="add mod">
          <ac:chgData name="Yuan Fu [yuf4]" userId="S::yuf4@aber.ac.uk::2bf4daa5-2f5c-4582-aaab-6a7f8d79dd1f" providerId="AD" clId="Web-{24EAC7A2-8929-EEDF-1005-E4F23D2BB211}" dt="2020-09-21T17:20:57.281" v="134" actId="20577"/>
          <ac:spMkLst>
            <pc:docMk/>
            <pc:sldMk cId="375304426" sldId="262"/>
            <ac:spMk id="2" creationId="{31D75A45-9EC1-40B9-928C-74BA94D506AB}"/>
          </ac:spMkLst>
        </pc:spChg>
        <pc:spChg chg="mod">
          <ac:chgData name="Yuan Fu [yuf4]" userId="S::yuf4@aber.ac.uk::2bf4daa5-2f5c-4582-aaab-6a7f8d79dd1f" providerId="AD" clId="Web-{24EAC7A2-8929-EEDF-1005-E4F23D2BB211}" dt="2020-09-21T17:28:22.696" v="196" actId="1076"/>
          <ac:spMkLst>
            <pc:docMk/>
            <pc:sldMk cId="375304426" sldId="262"/>
            <ac:spMk id="4" creationId="{64CD51AE-5507-499A-87EA-8F765194A2BF}"/>
          </ac:spMkLst>
        </pc:spChg>
      </pc:sldChg>
      <pc:sldChg chg="addSp modSp">
        <pc:chgData name="Yuan Fu [yuf4]" userId="S::yuf4@aber.ac.uk::2bf4daa5-2f5c-4582-aaab-6a7f8d79dd1f" providerId="AD" clId="Web-{24EAC7A2-8929-EEDF-1005-E4F23D2BB211}" dt="2020-09-21T17:28:22.727" v="197" actId="1076"/>
        <pc:sldMkLst>
          <pc:docMk/>
          <pc:sldMk cId="2644330033" sldId="263"/>
        </pc:sldMkLst>
        <pc:spChg chg="add mod">
          <ac:chgData name="Yuan Fu [yuf4]" userId="S::yuf4@aber.ac.uk::2bf4daa5-2f5c-4582-aaab-6a7f8d79dd1f" providerId="AD" clId="Web-{24EAC7A2-8929-EEDF-1005-E4F23D2BB211}" dt="2020-09-21T17:22:41.346" v="178" actId="20577"/>
          <ac:spMkLst>
            <pc:docMk/>
            <pc:sldMk cId="2644330033" sldId="263"/>
            <ac:spMk id="2" creationId="{51F6A66A-F12D-4EAB-90DF-2A983AF12312}"/>
          </ac:spMkLst>
        </pc:spChg>
        <pc:spChg chg="mod">
          <ac:chgData name="Yuan Fu [yuf4]" userId="S::yuf4@aber.ac.uk::2bf4daa5-2f5c-4582-aaab-6a7f8d79dd1f" providerId="AD" clId="Web-{24EAC7A2-8929-EEDF-1005-E4F23D2BB211}" dt="2020-09-21T17:28:22.727" v="197" actId="1076"/>
          <ac:spMkLst>
            <pc:docMk/>
            <pc:sldMk cId="2644330033" sldId="263"/>
            <ac:spMk id="4" creationId="{16C6D885-3D5E-495A-B008-CC29BA5CF5AE}"/>
          </ac:spMkLst>
        </pc:spChg>
      </pc:sldChg>
      <pc:sldChg chg="addSp del">
        <pc:chgData name="Yuan Fu [yuf4]" userId="S::yuf4@aber.ac.uk::2bf4daa5-2f5c-4582-aaab-6a7f8d79dd1f" providerId="AD" clId="Web-{24EAC7A2-8929-EEDF-1005-E4F23D2BB211}" dt="2020-09-21T17:19:44.717" v="101"/>
        <pc:sldMkLst>
          <pc:docMk/>
          <pc:sldMk cId="1250990985" sldId="264"/>
        </pc:sldMkLst>
        <pc:spChg chg="add">
          <ac:chgData name="Yuan Fu [yuf4]" userId="S::yuf4@aber.ac.uk::2bf4daa5-2f5c-4582-aaab-6a7f8d79dd1f" providerId="AD" clId="Web-{24EAC7A2-8929-EEDF-1005-E4F23D2BB211}" dt="2020-09-21T17:16:42.792" v="59"/>
          <ac:spMkLst>
            <pc:docMk/>
            <pc:sldMk cId="1250990985" sldId="264"/>
            <ac:spMk id="2" creationId="{86EC3069-6E46-4F8E-8F2F-88A246CEDBD1}"/>
          </ac:spMkLst>
        </pc:spChg>
      </pc:sldChg>
      <pc:sldChg chg="addSp del">
        <pc:chgData name="Yuan Fu [yuf4]" userId="S::yuf4@aber.ac.uk::2bf4daa5-2f5c-4582-aaab-6a7f8d79dd1f" providerId="AD" clId="Web-{24EAC7A2-8929-EEDF-1005-E4F23D2BB211}" dt="2020-09-21T17:19:44.717" v="102"/>
        <pc:sldMkLst>
          <pc:docMk/>
          <pc:sldMk cId="3314443409" sldId="265"/>
        </pc:sldMkLst>
        <pc:spChg chg="add">
          <ac:chgData name="Yuan Fu [yuf4]" userId="S::yuf4@aber.ac.uk::2bf4daa5-2f5c-4582-aaab-6a7f8d79dd1f" providerId="AD" clId="Web-{24EAC7A2-8929-EEDF-1005-E4F23D2BB211}" dt="2020-09-21T17:16:40.401" v="58"/>
          <ac:spMkLst>
            <pc:docMk/>
            <pc:sldMk cId="3314443409" sldId="265"/>
            <ac:spMk id="2" creationId="{C12773E2-FD5C-49CB-9E34-8D604BA386AB}"/>
          </ac:spMkLst>
        </pc:spChg>
      </pc:sldChg>
    </pc:docChg>
  </pc:docChgLst>
  <pc:docChgLst>
    <pc:chgData name="Yuan Fu [yuf4]" userId="S::yuf4@aber.ac.uk::2bf4daa5-2f5c-4582-aaab-6a7f8d79dd1f" providerId="AD" clId="Web-{F55533CB-BC61-E47E-90E7-A115DB9C5E27}"/>
    <pc:docChg chg="modSld">
      <pc:chgData name="Yuan Fu [yuf4]" userId="S::yuf4@aber.ac.uk::2bf4daa5-2f5c-4582-aaab-6a7f8d79dd1f" providerId="AD" clId="Web-{F55533CB-BC61-E47E-90E7-A115DB9C5E27}" dt="2019-10-25T17:15:08.090" v="11" actId="1076"/>
      <pc:docMkLst>
        <pc:docMk/>
      </pc:docMkLst>
      <pc:sldChg chg="addSp modSp">
        <pc:chgData name="Yuan Fu [yuf4]" userId="S::yuf4@aber.ac.uk::2bf4daa5-2f5c-4582-aaab-6a7f8d79dd1f" providerId="AD" clId="Web-{F55533CB-BC61-E47E-90E7-A115DB9C5E27}" dt="2019-10-25T17:15:08.090" v="11" actId="1076"/>
        <pc:sldMkLst>
          <pc:docMk/>
          <pc:sldMk cId="310228240" sldId="260"/>
        </pc:sldMkLst>
        <pc:picChg chg="add mod ord">
          <ac:chgData name="Yuan Fu [yuf4]" userId="S::yuf4@aber.ac.uk::2bf4daa5-2f5c-4582-aaab-6a7f8d79dd1f" providerId="AD" clId="Web-{F55533CB-BC61-E47E-90E7-A115DB9C5E27}" dt="2019-10-25T17:15:08.090" v="11" actId="1076"/>
          <ac:picMkLst>
            <pc:docMk/>
            <pc:sldMk cId="310228240" sldId="260"/>
            <ac:picMk id="2" creationId="{7D26005F-BD3F-4D96-999E-92F184453E24}"/>
          </ac:picMkLst>
        </pc:picChg>
      </pc:sldChg>
      <pc:sldChg chg="addSp modSp">
        <pc:chgData name="Yuan Fu [yuf4]" userId="S::yuf4@aber.ac.uk::2bf4daa5-2f5c-4582-aaab-6a7f8d79dd1f" providerId="AD" clId="Web-{F55533CB-BC61-E47E-90E7-A115DB9C5E27}" dt="2019-10-25T17:14:57.481" v="10" actId="1076"/>
        <pc:sldMkLst>
          <pc:docMk/>
          <pc:sldMk cId="1613560427" sldId="261"/>
        </pc:sldMkLst>
        <pc:picChg chg="add mod ord">
          <ac:chgData name="Yuan Fu [yuf4]" userId="S::yuf4@aber.ac.uk::2bf4daa5-2f5c-4582-aaab-6a7f8d79dd1f" providerId="AD" clId="Web-{F55533CB-BC61-E47E-90E7-A115DB9C5E27}" dt="2019-10-25T17:14:57.481" v="10" actId="1076"/>
          <ac:picMkLst>
            <pc:docMk/>
            <pc:sldMk cId="1613560427" sldId="261"/>
            <ac:picMk id="2" creationId="{7EBC41AD-CA2C-44FC-B284-43B9E45A080F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D4C2E8-A063-4D1F-8915-E16A4C16634E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AFC1F9-153F-4B16-B1C6-B5406EAB9A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80157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Ba12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AFC1F9-153F-4B16-B1C6-B5406EAB9AE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75664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Ba12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AFC1F9-153F-4B16-B1C6-B5406EAB9AE0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08512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33869E-9C0C-42A5-8F35-6F72BFB2E3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B598D24-A656-4D34-9B94-688510C808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AC14208-F57B-4CA2-894D-993D1AA5E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5CB64D-AA18-451C-A5DC-64767073D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4292E50-20AB-4537-A384-DD62F199C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0883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6A7DF0-6C81-43D0-ACFA-E6EF1FD20A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01BF501-395B-4C26-8F01-71D3070236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9DEFE3-83A8-4E0D-82D9-22412D67D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3057E87-86FB-4561-B33A-7AC347B29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E28D0F-9F75-4328-AC94-DF33469AF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2545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E1CFEDD-FF94-45FD-B091-320BF5D4AF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1059C65-7871-42EB-863A-2E1E2708A8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5FA017D-59F2-47EA-A38A-217ABBD80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523B7D8-641E-4C56-A02D-0FBDA2881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725C3C-601C-4B25-96F3-FFF4774A1D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1982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1D46DC-879D-48B5-89F4-7410652095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F58108D-253A-4645-AF24-0A4727305D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59690F-C9FC-43C9-BDED-8FAC780BA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4F38A6-4A41-42F7-BA6E-B9A780E53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1FABD1-910E-4452-A19C-BE6064657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1596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F16BBF-604E-461B-8D9B-2E5B31674A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3A6639B-8D40-42C6-B96F-43F22645A4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122204-22D2-40FC-BE58-7FE102D7CD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BBB375-4360-478F-9D3F-10DD96B08B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BBFEAA-209D-4EDE-984D-C85E53EF5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3368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DD97F9-2898-4212-B11D-87B696B052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C84440B-ED2E-4AD8-B6EA-3B45212EAF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987C32F-4991-44DC-972C-D3C69A385A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8BA88C-04EF-4C18-ADDE-11C45C74E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DCE01D4-CAEF-4A63-8615-F2F32799D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FE044B1-3E6C-4CC8-A3DC-61981131E8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5030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9C3076-B683-4334-8F8E-5B18C54EB4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C77E1AA-AAAA-4ADB-9DE6-5709B9CEA1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20C451-9B30-46C5-9018-5CA93F51D8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18366B2-A488-4221-AFC6-2090D7EF61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F501A1B-CF48-4C5D-9EB2-3C447FE8655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6757DCE-2E11-444D-85E3-6B6C98CB69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8067765-7A2D-4050-8BC9-E3F64E534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306DD80-6627-49A9-8E03-5CA04CA82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2857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0E0C5B-FABC-41B5-ABBD-5E6A61306F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5F67CC6-4EA3-4C8B-9B84-65453716D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D979354-DC15-4054-9572-47DEF9025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491615C-247E-4888-8D39-BE88D592B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1735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4910BB6-C8FB-4334-8CFF-15CEEF10A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21E3F29-56FF-4978-AF9C-40CF0DA43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508CBDF-3A16-4D05-A8DC-32750539C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8356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DC0AB8-7FA2-44DF-B120-53A291935F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DA15ABF-D555-4F90-94C6-531FA7CFB8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F767089-51AD-4AEB-AA3C-8150F3470B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C32D413-1E9B-433A-9D95-2CF5629B0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0C02D59-0C58-41D1-95E7-12694A2A5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5C0EE3-7235-4807-9FA0-E926ED2DF1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0881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CB8721-A79D-4C2D-8CB2-4A9A66B568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50E022A-E952-4191-92B9-933B3F466C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073CAAA-BCA4-43D8-B71B-D0FA5C6B2C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AA2E168-854A-4ADB-B08B-3C10214F7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9D05F69-2170-4AF7-B9E5-503A253BD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BC47770-E40A-44FB-841F-61C981129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5215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2532869-EFA9-400B-B22C-16AF4015C5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3474C27-B61A-4C5D-A3FD-92C2A3E944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A2D536-8C50-4BBF-8602-9696021691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6461D5-5359-4100-B3B3-03955660EE95}" type="datetimeFigureOut">
              <a:rPr lang="zh-CN" altLang="en-US" smtClean="0"/>
              <a:t>2021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F068AE-54C7-409F-BEB2-3D65C39AA0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F52859-BFAB-45C4-B72E-DA39680C13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2F2F8-5FEF-4754-881F-D82B93DC3D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7178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48261" y="141371"/>
            <a:ext cx="2670372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S1 Fig. First two principal components </a:t>
            </a:r>
            <a:r>
              <a:rPr lang="en-GB" sz="1400" b="1" dirty="0" smtClean="0"/>
              <a:t>(PCs) describing </a:t>
            </a:r>
            <a:r>
              <a:rPr lang="en-GB" sz="1400" b="1" dirty="0" smtClean="0"/>
              <a:t>the separation of the 4 replicates for each genotype for leaf and root at the estimated growing medium water content (EWC) sampling points</a:t>
            </a:r>
            <a:r>
              <a:rPr lang="en-GB" sz="1400" b="1" dirty="0" smtClean="0"/>
              <a:t>. 35%, 15%, 5% and 1% indicate the EWC at which the sample was taken. _1, _2, _3 and _4 indicate different replicates.</a:t>
            </a:r>
            <a:endParaRPr lang="en-GB" sz="1400" b="1" dirty="0" smtClean="0"/>
          </a:p>
          <a:p>
            <a:r>
              <a:rPr lang="en-GB" sz="1400" b="1" dirty="0" smtClean="0"/>
              <a:t>Slide 1 – Ba12 leaf</a:t>
            </a:r>
          </a:p>
          <a:p>
            <a:r>
              <a:rPr lang="en-GB" sz="1400" b="1" dirty="0" smtClean="0"/>
              <a:t>Slide 2 – Ba12 root</a:t>
            </a:r>
          </a:p>
          <a:p>
            <a:r>
              <a:rPr lang="en-GB" sz="1400" b="1" dirty="0" smtClean="0"/>
              <a:t>Slide 3</a:t>
            </a:r>
            <a:r>
              <a:rPr lang="en-GB" sz="1400" b="1" dirty="0"/>
              <a:t> – </a:t>
            </a:r>
            <a:r>
              <a:rPr lang="en-GB" sz="1400" b="1" dirty="0" smtClean="0"/>
              <a:t>Ba99 leaf</a:t>
            </a:r>
          </a:p>
          <a:p>
            <a:r>
              <a:rPr lang="en-GB" sz="1400" b="1" dirty="0" smtClean="0"/>
              <a:t>Slide 4 </a:t>
            </a:r>
            <a:r>
              <a:rPr lang="en-GB" sz="1400" b="1" dirty="0"/>
              <a:t>– </a:t>
            </a:r>
            <a:r>
              <a:rPr lang="en-GB" sz="1400" b="1" dirty="0" smtClean="0"/>
              <a:t>Ba99 root</a:t>
            </a:r>
          </a:p>
          <a:p>
            <a:r>
              <a:rPr lang="en-GB" sz="1400" b="1" dirty="0" smtClean="0"/>
              <a:t>Slide 5 – Bf11 leaf</a:t>
            </a:r>
          </a:p>
          <a:p>
            <a:r>
              <a:rPr lang="en-GB" sz="1400" b="1" dirty="0" smtClean="0"/>
              <a:t>Slide 6 – Bf11 root</a:t>
            </a:r>
          </a:p>
          <a:p>
            <a:r>
              <a:rPr lang="en-GB" sz="1400" b="1" dirty="0" smtClean="0"/>
              <a:t>Slide 7 – p194 leaf</a:t>
            </a:r>
          </a:p>
          <a:p>
            <a:r>
              <a:rPr lang="en-GB" sz="1400" b="1" dirty="0" smtClean="0"/>
              <a:t>Slide 8 – p194 root</a:t>
            </a:r>
            <a:endParaRPr lang="en-GB" sz="1400" b="1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7073" y="156472"/>
            <a:ext cx="9031002" cy="65317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32844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0156" y="154487"/>
            <a:ext cx="9021704" cy="65249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17761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5074" y="162439"/>
            <a:ext cx="9005147" cy="65130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51909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86528" y="167343"/>
            <a:ext cx="9028393" cy="65356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50500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5319" y="162437"/>
            <a:ext cx="8999195" cy="65087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2282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1395" y="186293"/>
            <a:ext cx="9003527" cy="6511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35604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85127" y="206140"/>
            <a:ext cx="8987340" cy="64729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3044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3293" y="186373"/>
            <a:ext cx="8564671" cy="64852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4330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15</Words>
  <Application>Microsoft Office PowerPoint</Application>
  <PresentationFormat>Widescreen</PresentationFormat>
  <Paragraphs>13</Paragraphs>
  <Slides>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等线</vt:lpstr>
      <vt:lpstr>等线 Light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an Fu [yuf4]</dc:creator>
  <cp:lastModifiedBy>xxx</cp:lastModifiedBy>
  <cp:revision>79</cp:revision>
  <dcterms:created xsi:type="dcterms:W3CDTF">2019-08-06T09:51:31Z</dcterms:created>
  <dcterms:modified xsi:type="dcterms:W3CDTF">2021-03-10T04:23:06Z</dcterms:modified>
</cp:coreProperties>
</file>